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61" r:id="rId2"/>
    <p:sldId id="263" r:id="rId3"/>
    <p:sldId id="258" r:id="rId4"/>
    <p:sldId id="257" r:id="rId5"/>
    <p:sldId id="262" r:id="rId6"/>
    <p:sldId id="256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90"/>
  </p:normalViewPr>
  <p:slideViewPr>
    <p:cSldViewPr snapToGrid="0" snapToObjects="1">
      <p:cViewPr varScale="1">
        <p:scale>
          <a:sx n="131" d="100"/>
          <a:sy n="131" d="100"/>
        </p:scale>
        <p:origin x="4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34F6EF-FD10-0140-AE20-310B3234B10B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5DD757-80DA-1748-BC86-E80A1C68BF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429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7A8429-B6A9-AB44-ACD9-0D9103F1C64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761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581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744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484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236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5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472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709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887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728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5063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945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7860BF-0E0B-A14E-B714-29FD88A88943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EE55A-60A4-B14B-9420-D89CCB2334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725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6602B-44E4-154C-A5B9-F0BEC97529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00456" y="1217332"/>
            <a:ext cx="7772400" cy="3622892"/>
          </a:xfrm>
        </p:spPr>
        <p:txBody>
          <a:bodyPr>
            <a:normAutofit/>
          </a:bodyPr>
          <a:lstStyle/>
          <a:p>
            <a:r>
              <a:rPr lang="en-US" sz="2700" b="1" dirty="0" err="1"/>
              <a:t>Preconceptional</a:t>
            </a:r>
            <a:r>
              <a:rPr lang="en-US" sz="2700" b="1" dirty="0"/>
              <a:t> lipid-based nutrient supplementation in two low-resource countries results in distinctly different IGF-1/mTOR placental responses</a:t>
            </a:r>
            <a:br>
              <a:rPr lang="en-US" sz="2700" b="1" dirty="0"/>
            </a:br>
            <a:br>
              <a:rPr lang="en-US" sz="2700" dirty="0"/>
            </a:br>
            <a:r>
              <a:rPr lang="en-US" sz="2700" b="1" dirty="0"/>
              <a:t>M Castillo-</a:t>
            </a:r>
            <a:r>
              <a:rPr lang="en-US" sz="2700" b="1" dirty="0" err="1"/>
              <a:t>Castrejon</a:t>
            </a:r>
            <a:br>
              <a:rPr lang="en-US" sz="2700" b="1" dirty="0"/>
            </a:br>
            <a:br>
              <a:rPr lang="en-US" sz="2700" dirty="0"/>
            </a:br>
            <a:r>
              <a:rPr lang="en-US" sz="2700" b="1" dirty="0"/>
              <a:t>Online Supplementary Material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9214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0DEDEF-C3AF-4B40-A7EA-F5CBB2ED16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70" y="0"/>
            <a:ext cx="887505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84072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542A403-2911-AE49-A74F-F3CD701751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" y="50800"/>
            <a:ext cx="8839200" cy="675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49103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B868240-4EC2-EE40-A8EA-CAFBE50664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01547"/>
            <a:ext cx="9144000" cy="52549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40882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F335A43-BF4E-0C4E-9BEA-3FC7ACC574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4903" y="0"/>
            <a:ext cx="737419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04605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06F8210-9027-F540-B452-D19C3CBDF4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43980"/>
            <a:ext cx="9144000" cy="6170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4428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28</Words>
  <Application>Microsoft Macintosh PowerPoint</Application>
  <PresentationFormat>On-screen Show (4:3)</PresentationFormat>
  <Paragraphs>2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econceptional lipid-based nutrient supplementation in two low-resource countries results in distinctly different IGF-1/mTOR placental responses  M Castillo-Castrejon  Online Supplementary Material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stillo-Castrejon, Marisol</dc:creator>
  <cp:lastModifiedBy>Microsoft Office User</cp:lastModifiedBy>
  <cp:revision>7</cp:revision>
  <dcterms:created xsi:type="dcterms:W3CDTF">2020-09-09T01:36:05Z</dcterms:created>
  <dcterms:modified xsi:type="dcterms:W3CDTF">2020-12-11T16:07:53Z</dcterms:modified>
</cp:coreProperties>
</file>